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323EC7-DCD3-6544-9ECA-F777BC3974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CD9BA9C-12AD-5043-93D5-9645DF7AF0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C943F8-37E6-DE44-A463-94903841AF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973393-E534-6245-951C-43467AAC39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DB9B87F-51EB-BD4C-B3D0-54831899F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251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6EBF30-E59D-AC44-AD45-5677DE3005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17D6EF8-6896-4349-988E-15488DCB4D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A64AD6-8AF5-D54B-80C6-6204D5A66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3EE14D7-D6CB-4548-B990-33FFD7367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A8AE18-F4A1-9241-AF68-D78A7A930B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849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CD704AD-AB01-BB4D-9DE6-57CFB79BD4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223811A-8071-4942-B59A-42F7CFAC24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00B2B7-61E3-894F-B967-78A569655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E119B2-20DF-FE46-B663-43E0286FA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53BF00-7566-424C-8B3B-83D9EF91B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097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8A27D3-D5D6-E840-BC3E-3407B446C6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8CA1EC9-2845-5741-9905-CCE318BA37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FD5C294-CDF9-1D46-9190-82CE5A053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9B01F30-7DCE-8D42-9D4E-6F7F66575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92155AB-47AE-B54C-8C88-2290996C9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612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D74B2D-4233-CF47-80EE-14BB431455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49D132A-226F-EB46-AEC4-D4635694C2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8B6D57-D501-D54F-AAD5-664011515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01729E-6D47-7C40-A36C-33EC14BA8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AF65C69-65FD-C84A-BCD7-00794D34F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8601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308BE1-AA76-E541-ADCB-8C45229935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C3667D-74A4-4D4B-90AA-D555D43C1C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697D39C-814B-EC40-966A-19AB56A8E9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35F40AD-3633-E44C-895B-38402FC3B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DF2A63A-ECB5-2F4E-9190-CA84C2F3E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B1BB94E-6F6A-024D-8F34-04EC7AE82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670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FBC0C4-7DF6-334C-8F65-3D53C3695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F5F11FD-4FB7-A64F-873D-C44775033A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72AEF8F-5C31-354F-A27F-CECE20ECFB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B987B1A-88FF-D347-B94D-074786F59C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8256375-4210-8C49-B0B1-63675B1F45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B50FDF4-365C-2241-A192-584A50CD9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11BDA7B-E9BF-8F4E-816B-568DAB9CD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B7E3383-4859-554C-BE90-0256B893E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8403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E6DB32-DA2D-AE4C-8263-4D1440E7E4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BE6AD17-D02C-1646-A436-F96C24EBB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7DACD06-D450-C944-8181-A63FC9890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E3E86F9-F6B8-C641-BD89-D479B3DCE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267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0845023-B41C-BC44-BDE2-13EB9C186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65BC92D-B0D0-0049-9082-EB544CD33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A9BD950-4831-D747-AC03-B197830C9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951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BA2A3E-F399-454E-91AC-EDE9E794E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9BF8532-ED42-2F43-A6C1-DCB32C9E56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45DB26A-3139-5142-ACC3-DFDD66AEED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EA536ED-EE42-494E-949F-D068F091A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E0CB0FE-C330-0C43-A695-3BDF4FF549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2C834F6-0124-B54B-90A2-F2A4AE0115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8112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E1F601-D887-524F-972F-FA870C0D8F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772C18A-7AA2-C44C-8A46-A71386BF43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8145E78-FF97-DE4E-9C5D-43E67A9CFC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9E2CF68-5660-3B48-8EA1-317BA04D4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829BE6-2B22-2545-B701-B9B3EEBCE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607951-1CCD-D142-9915-F7444A94D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8236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D7F60DF-5E87-924F-ABCC-42E3605B6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72B63D-9F4D-8744-8852-DB32F320D3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9C4D925-608E-7341-81B9-91596923CB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961894-B28F-9C42-9D25-39ECA7B12EE8}" type="datetimeFigureOut">
              <a:rPr kumimoji="1" lang="ja-JP" altLang="en-US" smtClean="0"/>
              <a:t>2022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924418-6F24-484A-8CA3-E959E32F8E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51790E-BEDA-BE48-BFB5-7FEDB337AD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01319-52B1-D643-A47A-BC0892EB98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154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CF817D0-4734-42FF-8E58-4769A59B13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538" y="62883"/>
            <a:ext cx="5596512" cy="5596512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465272" y="5594788"/>
            <a:ext cx="1143729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l Figure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. </a:t>
            </a:r>
            <a:r>
              <a:rPr lang="en-US" altLang="ja-JP" sz="1800" b="1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Kaplan–Meier curve of overall survival (OS) rate of patients with CRPC after </a:t>
            </a:r>
            <a:r>
              <a:rPr lang="en-US" altLang="ja-JP" sz="1800" b="1" kern="1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abazitaxel</a:t>
            </a:r>
            <a:r>
              <a:rPr lang="en-US" altLang="ja-JP" sz="1800" b="1" kern="1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treatment, with or without PSA response.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roup A, Patients with PSA decline; Group B, Patients without PSA decline at 3 months after CBZ administration, analyzed by log-rank test.</a:t>
            </a:r>
            <a:endParaRPr kumimoji="1" lang="ja-JP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F0266F76-2430-41DD-BC99-AF79AAF868C5}"/>
              </a:ext>
            </a:extLst>
          </p:cNvPr>
          <p:cNvSpPr/>
          <p:nvPr/>
        </p:nvSpPr>
        <p:spPr>
          <a:xfrm>
            <a:off x="5592506" y="2530294"/>
            <a:ext cx="6310059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otal N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= 48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rvival rate at median observation period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[95% CI];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　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roup A (n = 28): 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.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91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[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.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700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- 0.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964]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　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roup B (n = 20): 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.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50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[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.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31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- 0.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47]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edian overall survival (days) [95% CI];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　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roup A (n = 28): 575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[418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-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38]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　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roup B (n = 20): 323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[231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-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17]		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R 2.84 [95% CI, 1.22 - 6.57];  </a:t>
            </a:r>
            <a:r>
              <a:rPr kumimoji="1" lang="en-US" altLang="ja-JP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= 0.00173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006746" y="721438"/>
            <a:ext cx="3262496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roup A; With PSA declin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roup B; Without PSA decline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cxnSp>
        <p:nvCxnSpPr>
          <p:cNvPr id="10" name="直線コネクタ 9"/>
          <p:cNvCxnSpPr/>
          <p:nvPr/>
        </p:nvCxnSpPr>
        <p:spPr>
          <a:xfrm>
            <a:off x="3105583" y="1207008"/>
            <a:ext cx="832104" cy="0"/>
          </a:xfrm>
          <a:prstGeom prst="line">
            <a:avLst/>
          </a:prstGeom>
          <a:ln w="222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3105583" y="941832"/>
            <a:ext cx="83210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697441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5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游明朝</vt:lpstr>
      <vt:lpstr>Arial</vt:lpstr>
      <vt:lpstr>1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永田 政義</dc:creator>
  <cp:lastModifiedBy>kamataikyoku@gmail.com</cp:lastModifiedBy>
  <cp:revision>3</cp:revision>
  <dcterms:created xsi:type="dcterms:W3CDTF">2022-09-06T11:26:15Z</dcterms:created>
  <dcterms:modified xsi:type="dcterms:W3CDTF">2022-09-18T01:09:03Z</dcterms:modified>
</cp:coreProperties>
</file>